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024EFE-1EAC-40EE-A348-3C2ACDEE2F9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285A98-2474-4E04-8BCE-55FF72AAFF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393A58-E2EB-40BF-A61D-A68D61A3DD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EA3FE3-F783-40B6-999E-DDF05B2505E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17E18D-76F0-4419-9B08-660BC8DA8C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5E2C75-8DDF-46A3-B76C-EA9E49D86F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D3447F-5CBC-4D10-967E-CA367FFEC4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FF50EF-8920-4D3E-91BD-9BE704C1F7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1505CB-F19D-4E65-92E2-5E6127AD2E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A58F9A-A362-45DD-AD9D-4E6E512C6B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3D46A3-6C0D-4E5C-B71E-6EEB4584A1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E25D0C-F84D-401C-A4D9-6139091962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1E2779-8587-4200-B426-3638FBD8EE4A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34800" y="1908000"/>
          <a:ext cx="6172200" cy="1476720"/>
        </p:xfrm>
        <a:graphic>
          <a:graphicData uri="http://schemas.openxmlformats.org/drawingml/2006/table">
            <a:tbl>
              <a:tblPr/>
              <a:tblGrid>
                <a:gridCol w="1866960"/>
                <a:gridCol w="1076400"/>
                <a:gridCol w="1076400"/>
                <a:gridCol w="1076400"/>
                <a:gridCol w="1076040"/>
              </a:tblGrid>
              <a:tr h="540000"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D +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fepristone (mg/kg BW/day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8360"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 body weight [g]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.9 </a:t>
                      </a:r>
                      <a:r>
                        <a:rPr b="0" lang="en-GB" sz="1000" spc="-1" strike="noStrike" u="sng">
                          <a:solidFill>
                            <a:srgbClr val="000000"/>
                          </a:solidFill>
                          <a:uFillTx/>
                          <a:latin typeface="Times New Roman"/>
                          <a:ea typeface="Times New Roman"/>
                        </a:rPr>
                        <a:t>+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0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.9 </a:t>
                      </a:r>
                      <a:r>
                        <a:rPr b="0" lang="en-GB" sz="1000" spc="-1" strike="noStrike" u="sng">
                          <a:solidFill>
                            <a:srgbClr val="000000"/>
                          </a:solidFill>
                          <a:uFillTx/>
                          <a:latin typeface="Times New Roman"/>
                          <a:ea typeface="Times New Roman"/>
                        </a:rPr>
                        <a:t>+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0.6 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.1 </a:t>
                      </a:r>
                      <a:r>
                        <a:rPr b="0" lang="en-GB" sz="1000" spc="-1" strike="noStrike" u="sng">
                          <a:solidFill>
                            <a:srgbClr val="000000"/>
                          </a:solidFill>
                          <a:uFillTx/>
                          <a:latin typeface="Times New Roman"/>
                          <a:ea typeface="Times New Roman"/>
                        </a:rPr>
                        <a:t>+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0.8 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.6 </a:t>
                      </a:r>
                      <a:r>
                        <a:rPr b="0" lang="en-GB" sz="1000" spc="-1" strike="noStrike" u="sng">
                          <a:solidFill>
                            <a:srgbClr val="000000"/>
                          </a:solidFill>
                          <a:uFillTx/>
                          <a:latin typeface="Times New Roman"/>
                          <a:ea typeface="Times New Roman"/>
                        </a:rPr>
                        <a:t>+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0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8360"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sting blood glucose [mg/dL]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6.7 </a:t>
                      </a:r>
                      <a:r>
                        <a:rPr b="0" lang="en-GB" sz="1000" spc="-1" strike="noStrike" u="sng">
                          <a:solidFill>
                            <a:srgbClr val="000000"/>
                          </a:solidFill>
                          <a:uFillTx/>
                          <a:latin typeface="Times New Roman"/>
                          <a:ea typeface="Times New Roman"/>
                        </a:rPr>
                        <a:t>+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7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5.8 </a:t>
                      </a:r>
                      <a:r>
                        <a:rPr b="0" lang="en-GB" sz="1000" spc="-1" strike="noStrike" u="sng">
                          <a:solidFill>
                            <a:srgbClr val="000000"/>
                          </a:solidFill>
                          <a:uFillTx/>
                          <a:latin typeface="Times New Roman"/>
                          <a:ea typeface="Times New Roman"/>
                        </a:rPr>
                        <a:t>+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4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0.5 </a:t>
                      </a:r>
                      <a:r>
                        <a:rPr b="0" lang="en-GB" sz="1000" spc="-1" strike="noStrike" u="sng">
                          <a:solidFill>
                            <a:srgbClr val="000000"/>
                          </a:solidFill>
                          <a:uFillTx/>
                          <a:latin typeface="Times New Roman"/>
                          <a:ea typeface="Times New Roman"/>
                        </a:rPr>
                        <a:t>+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8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5.2 </a:t>
                      </a:r>
                      <a:r>
                        <a:rPr b="0" lang="en-GB" sz="1000" spc="-1" strike="noStrike" u="sng">
                          <a:solidFill>
                            <a:srgbClr val="000000"/>
                          </a:solidFill>
                          <a:uFillTx/>
                          <a:latin typeface="Times New Roman"/>
                          <a:ea typeface="Times New Roman"/>
                        </a:rPr>
                        <a:t>+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7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正方形/長方形 4"/>
          <p:cNvSpPr/>
          <p:nvPr/>
        </p:nvSpPr>
        <p:spPr>
          <a:xfrm>
            <a:off x="250920" y="1403280"/>
            <a:ext cx="101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gular Die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正方形/長方形 6"/>
          <p:cNvSpPr/>
          <p:nvPr/>
        </p:nvSpPr>
        <p:spPr>
          <a:xfrm>
            <a:off x="254160" y="1000080"/>
            <a:ext cx="75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正方形/長方形 2"/>
          <p:cNvSpPr/>
          <p:nvPr/>
        </p:nvSpPr>
        <p:spPr>
          <a:xfrm>
            <a:off x="285840" y="4140360"/>
            <a:ext cx="6254640" cy="1348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1. Parameters of regular diet mic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ven-week-old C57BL/6NCr Slc mice received regular diet (RD) and were orally treated with either mifepristone (0.1, 1 or 30 mg/kg bw/day) or vehicle (RD alone) for twenty-two consecutive weeks (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= 8 in each group). At the age of week 28, animals were subjected to fasting blood glucose test.  *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&lt; 0.05, **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&lt; 0.01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rsus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D fed mice that did not receive mifepristone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06T06:04:58Z</dcterms:created>
  <dc:creator>Takeshi Hashimoto</dc:creator>
  <dc:description/>
  <dc:language>en-US</dc:language>
  <cp:lastModifiedBy>Physiol2-12</cp:lastModifiedBy>
  <cp:lastPrinted>2013-02-19T23:03:05Z</cp:lastPrinted>
  <dcterms:modified xsi:type="dcterms:W3CDTF">2013-10-21T00:31:37Z</dcterms:modified>
  <cp:revision>443</cp:revision>
  <dc:subject/>
  <dc:title>スライド 1</dc:title>
</cp:coreProperties>
</file>